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92913" cy="9982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88107D-6A2C-4BED-9B9C-FA91DAB9D8C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7C4246-F603-4403-B451-5809FCB2AA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EC2D57-39B0-43E9-B7DC-D0817D382FB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2DD0B8-F8DD-4C12-BDE2-86C083984E5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DE9642C-AAA7-4FD0-9D14-86F6A1C5559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71EA44-6691-4680-8D72-F2D37F06BA3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433AB7F-5B5E-477E-A6ED-CB573A952A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B1DCFD-E39A-4506-8F65-406B03D6B71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8EFA62-0DD7-4597-9D0C-C3DEC7F62A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1AF34C-49E8-407B-BAD3-335C14162A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7CAD7F-BC1C-4FB7-A3E0-2ADF8B77C84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CE3016-B4CA-4B8C-A947-8BBCDF31F1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2396311-1AD3-4378-AC3B-FF84F24BC77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333399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3059280" y="549360"/>
            <a:ext cx="1800000" cy="2952720"/>
          </a:xfrm>
          <a:prstGeom prst="ellipse">
            <a:avLst/>
          </a:prstGeom>
          <a:solidFill>
            <a:srgbClr val="ffcc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66"/>
                </a:solidFill>
                <a:latin typeface="Arial"/>
              </a:rPr>
              <a:t>Professiona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66"/>
                </a:solidFill>
                <a:latin typeface="Arial"/>
              </a:rPr>
              <a:t>values an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000" spc="-1" strike="noStrike">
                <a:solidFill>
                  <a:srgbClr val="000066"/>
                </a:solidFill>
                <a:latin typeface="Arial"/>
              </a:rPr>
              <a:t>experience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3059280" y="3070080"/>
            <a:ext cx="1800000" cy="2880000"/>
          </a:xfrm>
          <a:prstGeom prst="ellipse">
            <a:avLst/>
          </a:prstGeom>
          <a:solidFill>
            <a:srgbClr val="ffcc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66"/>
                </a:solidFill>
                <a:latin typeface="Arial"/>
              </a:rPr>
              <a:t>Personal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66"/>
                </a:solidFill>
                <a:latin typeface="Arial"/>
              </a:rPr>
              <a:t>values an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66"/>
                </a:solidFill>
                <a:latin typeface="Arial"/>
              </a:rPr>
              <a:t>experience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539640" y="476280"/>
            <a:ext cx="8209080" cy="5905440"/>
          </a:xfrm>
          <a:prstGeom prst="rect">
            <a:avLst/>
          </a:prstGeom>
          <a:noFill/>
          <a:ln w="1908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7020000" y="1916280"/>
            <a:ext cx="1584360" cy="2665080"/>
          </a:xfrm>
          <a:prstGeom prst="rect">
            <a:avLst/>
          </a:prstGeom>
          <a:solidFill>
            <a:srgbClr val="ffcc99"/>
          </a:solidFill>
          <a:ln w="9360">
            <a:solidFill>
              <a:srgbClr val="0000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66"/>
                </a:solidFill>
                <a:latin typeface="Arial"/>
              </a:rPr>
              <a:t>Patien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66"/>
                </a:solidFill>
                <a:latin typeface="Arial"/>
              </a:rPr>
              <a:t>and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66"/>
                </a:solidFill>
                <a:latin typeface="Arial"/>
              </a:rPr>
              <a:t>environ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400" spc="-1" strike="noStrike">
                <a:solidFill>
                  <a:srgbClr val="000066"/>
                </a:solidFill>
                <a:latin typeface="Arial"/>
              </a:rPr>
              <a:t>men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492360" y="2708280"/>
            <a:ext cx="2737080" cy="1081080"/>
          </a:xfrm>
          <a:prstGeom prst="ellipse">
            <a:avLst/>
          </a:prstGeom>
          <a:solidFill>
            <a:srgbClr val="ff7d00"/>
          </a:solidFill>
          <a:ln w="9360">
            <a:solidFill>
              <a:srgbClr val="151354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151354"/>
                </a:solidFill>
                <a:latin typeface="Arial"/>
              </a:rPr>
              <a:t>Good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nl-NL" sz="2000" spc="-1" strike="noStrike">
                <a:solidFill>
                  <a:srgbClr val="151354"/>
                </a:solidFill>
                <a:latin typeface="Arial"/>
              </a:rPr>
              <a:t>death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 flipH="1">
            <a:off x="6300720" y="3213000"/>
            <a:ext cx="433440" cy="0"/>
          </a:xfrm>
          <a:prstGeom prst="line">
            <a:avLst/>
          </a:prstGeom>
          <a:ln w="38160">
            <a:solidFill>
              <a:srgbClr val="ffffff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738360" y="1916280"/>
            <a:ext cx="1601640" cy="2665080"/>
          </a:xfrm>
          <a:prstGeom prst="rect">
            <a:avLst/>
          </a:prstGeom>
          <a:solidFill>
            <a:srgbClr val="ffcc99"/>
          </a:solidFill>
          <a:ln w="9360">
            <a:solidFill>
              <a:srgbClr val="000066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66"/>
                </a:solidFill>
                <a:latin typeface="Arial"/>
              </a:rPr>
              <a:t>GP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 flipH="1">
            <a:off x="5076360" y="2205000"/>
            <a:ext cx="1800360" cy="0"/>
          </a:xfrm>
          <a:prstGeom prst="line">
            <a:avLst/>
          </a:prstGeom>
          <a:ln w="38160">
            <a:solidFill>
              <a:srgbClr val="ffffff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 flipH="1">
            <a:off x="5076360" y="4365720"/>
            <a:ext cx="1800360" cy="0"/>
          </a:xfrm>
          <a:prstGeom prst="line">
            <a:avLst/>
          </a:prstGeom>
          <a:ln w="38160">
            <a:solidFill>
              <a:srgbClr val="ffffff"/>
            </a:solidFill>
            <a:miter/>
            <a:headEnd len="med" type="triangle" w="med"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 flipH="1">
            <a:off x="2484360" y="2205000"/>
            <a:ext cx="432000" cy="0"/>
          </a:xfrm>
          <a:prstGeom prst="line">
            <a:avLst/>
          </a:prstGeom>
          <a:ln w="38160">
            <a:solidFill>
              <a:srgbClr val="ffffff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 flipH="1">
            <a:off x="2484360" y="4365720"/>
            <a:ext cx="432000" cy="0"/>
          </a:xfrm>
          <a:prstGeom prst="line">
            <a:avLst/>
          </a:prstGeom>
          <a:ln w="38160">
            <a:solidFill>
              <a:srgbClr val="ffffff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flipH="1">
            <a:off x="2484360" y="3213000"/>
            <a:ext cx="432000" cy="0"/>
          </a:xfrm>
          <a:prstGeom prst="line">
            <a:avLst/>
          </a:prstGeom>
          <a:ln w="38160">
            <a:solidFill>
              <a:srgbClr val="ffffff"/>
            </a:solidFill>
            <a:miter/>
            <a:head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7-01T08:33:55Z</dcterms:created>
  <dc:creator>P160663</dc:creator>
  <dc:description/>
  <dc:language>en-US</dc:language>
  <cp:lastModifiedBy>P160663</cp:lastModifiedBy>
  <dcterms:modified xsi:type="dcterms:W3CDTF">2009-10-06T08:27:03Z</dcterms:modified>
  <cp:revision>24</cp:revision>
  <dc:subject/>
  <dc:title>Slide 1</dc:title>
</cp:coreProperties>
</file>